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777" autoAdjust="0"/>
    <p:restoredTop sz="94660"/>
  </p:normalViewPr>
  <p:slideViewPr>
    <p:cSldViewPr>
      <p:cViewPr>
        <p:scale>
          <a:sx n="66" d="100"/>
          <a:sy n="66" d="100"/>
        </p:scale>
        <p:origin x="-3348" y="-1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idoli\Michelle\New%20analysis%20-%20EpiProfil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doli\Michelle\New%20analysis%20-%20EpiProfil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doli\Michelle\New%20analysis%20-%20EpiProfil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doli\Michelle\New%20analysis%20-%20EpiProfil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doli\Michelle\New%20analysis%20-%20EpiProfile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doli\Michelle\New%20analysis%20-%20EpiProfile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doli\Michelle\New%20analysis%20-%20EpiProfi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PCA diff comb'!$A$2</c:f>
              <c:strCache>
                <c:ptCount val="1"/>
                <c:pt idx="0">
                  <c:v>ESCs A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3.3116127864253303E-2"/>
                  <c:y val="-4.53481335666375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2</c:f>
              <c:numCache>
                <c:formatCode>General</c:formatCode>
                <c:ptCount val="1"/>
                <c:pt idx="0">
                  <c:v>-0.22640589999999999</c:v>
                </c:pt>
              </c:numCache>
            </c:numRef>
          </c:xVal>
          <c:yVal>
            <c:numRef>
              <c:f>'PCA diff comb'!$C$2</c:f>
              <c:numCache>
                <c:formatCode>General</c:formatCode>
                <c:ptCount val="1"/>
                <c:pt idx="0">
                  <c:v>8.1372399999999998E-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CA diff comb'!$A$3</c:f>
              <c:strCache>
                <c:ptCount val="1"/>
                <c:pt idx="0">
                  <c:v>ESCs B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6.2082320134725602E-2"/>
                  <c:y val="5.4765602216389597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3</c:f>
              <c:numCache>
                <c:formatCode>General</c:formatCode>
                <c:ptCount val="1"/>
                <c:pt idx="0">
                  <c:v>-0.23608499999999999</c:v>
                </c:pt>
              </c:numCache>
            </c:numRef>
          </c:xVal>
          <c:yVal>
            <c:numRef>
              <c:f>'PCA diff comb'!$C$3</c:f>
              <c:numCache>
                <c:formatCode>General</c:formatCode>
                <c:ptCount val="1"/>
                <c:pt idx="0">
                  <c:v>7.1070449999999993E-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PCA diff comb'!$A$4</c:f>
              <c:strCache>
                <c:ptCount val="1"/>
                <c:pt idx="0">
                  <c:v>EBs A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0.12006320351316099"/>
                  <c:y val="-4.5506257110352701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4</c:f>
              <c:numCache>
                <c:formatCode>General</c:formatCode>
                <c:ptCount val="1"/>
                <c:pt idx="0">
                  <c:v>-9.4331910000000005E-2</c:v>
                </c:pt>
              </c:numCache>
            </c:numRef>
          </c:xVal>
          <c:yVal>
            <c:numRef>
              <c:f>'PCA diff comb'!$C$4</c:f>
              <c:numCache>
                <c:formatCode>General</c:formatCode>
                <c:ptCount val="1"/>
                <c:pt idx="0">
                  <c:v>-0.22099240000000001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PCA diff comb'!$A$5</c:f>
              <c:strCache>
                <c:ptCount val="1"/>
                <c:pt idx="0">
                  <c:v>EBs B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9.1116239875068797E-2"/>
                  <c:y val="5.0214712744240303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5</c:f>
              <c:numCache>
                <c:formatCode>General</c:formatCode>
                <c:ptCount val="1"/>
                <c:pt idx="0">
                  <c:v>3.5158210000000002E-2</c:v>
                </c:pt>
              </c:numCache>
            </c:numRef>
          </c:xVal>
          <c:yVal>
            <c:numRef>
              <c:f>'PCA diff comb'!$C$5</c:f>
              <c:numCache>
                <c:formatCode>General</c:formatCode>
                <c:ptCount val="1"/>
                <c:pt idx="0">
                  <c:v>-8.5592390000000004E-2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PCA diff comb'!$A$6</c:f>
              <c:strCache>
                <c:ptCount val="1"/>
                <c:pt idx="0">
                  <c:v>1d RA A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0.24467109580052501"/>
                  <c:y val="2.1869845872693399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6</c:f>
              <c:numCache>
                <c:formatCode>General</c:formatCode>
                <c:ptCount val="1"/>
                <c:pt idx="0">
                  <c:v>6.8349530000000006E-2</c:v>
                </c:pt>
              </c:numCache>
            </c:numRef>
          </c:xVal>
          <c:yVal>
            <c:numRef>
              <c:f>'PCA diff comb'!$C$6</c:f>
              <c:numCache>
                <c:formatCode>General</c:formatCode>
                <c:ptCount val="1"/>
                <c:pt idx="0">
                  <c:v>-3.9675839999999997E-2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'PCA diff comb'!$A$7</c:f>
              <c:strCache>
                <c:ptCount val="1"/>
                <c:pt idx="0">
                  <c:v>1d RA B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5.37342582474475E-2"/>
                  <c:y val="5.9790026246719197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7</c:f>
              <c:numCache>
                <c:formatCode>General</c:formatCode>
                <c:ptCount val="1"/>
                <c:pt idx="0">
                  <c:v>7.8814709999999996E-2</c:v>
                </c:pt>
              </c:numCache>
            </c:numRef>
          </c:xVal>
          <c:yVal>
            <c:numRef>
              <c:f>'PCA diff comb'!$C$7</c:f>
              <c:numCache>
                <c:formatCode>General</c:formatCode>
                <c:ptCount val="1"/>
                <c:pt idx="0">
                  <c:v>-1.5530199999999999E-2</c:v>
                </c:pt>
              </c:numCache>
            </c:numRef>
          </c:yVal>
          <c:smooth val="0"/>
        </c:ser>
        <c:ser>
          <c:idx val="6"/>
          <c:order val="6"/>
          <c:tx>
            <c:strRef>
              <c:f>'PCA diff comb'!$A$8</c:f>
              <c:strCache>
                <c:ptCount val="1"/>
                <c:pt idx="0">
                  <c:v>4d RA A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1.6560441863884199E-2"/>
                  <c:y val="-2.2753128555176302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8</c:f>
              <c:numCache>
                <c:formatCode>General</c:formatCode>
                <c:ptCount val="1"/>
                <c:pt idx="0">
                  <c:v>9.7899760000000002E-2</c:v>
                </c:pt>
              </c:numCache>
            </c:numRef>
          </c:xVal>
          <c:yVal>
            <c:numRef>
              <c:f>'PCA diff comb'!$C$8</c:f>
              <c:numCache>
                <c:formatCode>General</c:formatCode>
                <c:ptCount val="1"/>
                <c:pt idx="0">
                  <c:v>1.1362519999999999E-2</c:v>
                </c:pt>
              </c:numCache>
            </c:numRef>
          </c:yVal>
          <c:smooth val="0"/>
        </c:ser>
        <c:ser>
          <c:idx val="7"/>
          <c:order val="7"/>
          <c:tx>
            <c:strRef>
              <c:f>'PCA diff comb'!$A$9</c:f>
              <c:strCache>
                <c:ptCount val="1"/>
                <c:pt idx="0">
                  <c:v>4d RA B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0.169744529104814"/>
                  <c:y val="-4.0955631399317398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xVal>
            <c:numRef>
              <c:f>'PCA diff comb'!$B$9</c:f>
              <c:numCache>
                <c:formatCode>General</c:formatCode>
                <c:ptCount val="1"/>
                <c:pt idx="0">
                  <c:v>6.7448010000000003E-2</c:v>
                </c:pt>
              </c:numCache>
            </c:numRef>
          </c:xVal>
          <c:yVal>
            <c:numRef>
              <c:f>'PCA diff comb'!$C$9</c:f>
              <c:numCache>
                <c:formatCode>General</c:formatCode>
                <c:ptCount val="1"/>
                <c:pt idx="0">
                  <c:v>1.4075010000000001E-2</c:v>
                </c:pt>
              </c:numCache>
            </c:numRef>
          </c:yVal>
          <c:smooth val="0"/>
        </c:ser>
        <c:ser>
          <c:idx val="8"/>
          <c:order val="8"/>
          <c:tx>
            <c:strRef>
              <c:f>'PCA diff comb'!$A$10</c:f>
              <c:strCache>
                <c:ptCount val="1"/>
                <c:pt idx="0">
                  <c:v>7d RA A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1.24203313979132E-2"/>
                  <c:y val="-2.2753128555176302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PCA diff comb'!$B$10</c:f>
              <c:numCache>
                <c:formatCode>General</c:formatCode>
                <c:ptCount val="1"/>
                <c:pt idx="0">
                  <c:v>0.1272325</c:v>
                </c:pt>
              </c:numCache>
            </c:numRef>
          </c:xVal>
          <c:yVal>
            <c:numRef>
              <c:f>'PCA diff comb'!$C$10</c:f>
              <c:numCache>
                <c:formatCode>General</c:formatCode>
                <c:ptCount val="1"/>
                <c:pt idx="0">
                  <c:v>9.2086050000000003E-2</c:v>
                </c:pt>
              </c:numCache>
            </c:numRef>
          </c:yVal>
          <c:smooth val="0"/>
        </c:ser>
        <c:ser>
          <c:idx val="9"/>
          <c:order val="9"/>
          <c:tx>
            <c:strRef>
              <c:f>'PCA diff comb'!$A$11</c:f>
              <c:strCache>
                <c:ptCount val="1"/>
                <c:pt idx="0">
                  <c:v>7d RA B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-0.16971559672459499"/>
                  <c:y val="-4.5269393409157199E-2"/>
                </c:manualLayout>
              </c:layout>
              <c:showLegendKey val="0"/>
              <c:showVal val="0"/>
              <c:showCatName val="0"/>
              <c:showSerName val="1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xVal>
            <c:numRef>
              <c:f>'PCA diff comb'!$B$11</c:f>
              <c:numCache>
                <c:formatCode>General</c:formatCode>
                <c:ptCount val="1"/>
                <c:pt idx="0">
                  <c:v>8.1920030000000005E-2</c:v>
                </c:pt>
              </c:numCache>
            </c:numRef>
          </c:xVal>
          <c:yVal>
            <c:numRef>
              <c:f>'PCA diff comb'!$C$11</c:f>
              <c:numCache>
                <c:formatCode>General</c:formatCode>
                <c:ptCount val="1"/>
                <c:pt idx="0">
                  <c:v>9.1824450000000002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812608"/>
        <c:axId val="84578304"/>
      </c:scatterChart>
      <c:valAx>
        <c:axId val="95812608"/>
        <c:scaling>
          <c:orientation val="minMax"/>
          <c:max val="0.3"/>
          <c:min val="-0.3"/>
        </c:scaling>
        <c:delete val="0"/>
        <c:axPos val="b"/>
        <c:numFmt formatCode="General" sourceLinked="1"/>
        <c:majorTickMark val="out"/>
        <c:minorTickMark val="none"/>
        <c:tickLblPos val="low"/>
        <c:crossAx val="84578304"/>
        <c:crosses val="autoZero"/>
        <c:crossBetween val="midCat"/>
        <c:majorUnit val="0.1"/>
      </c:valAx>
      <c:valAx>
        <c:axId val="84578304"/>
        <c:scaling>
          <c:orientation val="minMax"/>
          <c:max val="0.3"/>
          <c:min val="-0.3"/>
        </c:scaling>
        <c:delete val="0"/>
        <c:axPos val="l"/>
        <c:numFmt formatCode="General" sourceLinked="1"/>
        <c:majorTickMark val="out"/>
        <c:minorTickMark val="none"/>
        <c:tickLblPos val="low"/>
        <c:crossAx val="95812608"/>
        <c:crosses val="autoZero"/>
        <c:crossBetween val="midCat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5"/>
    </mc:Choice>
    <mc:Fallback>
      <c:style val="35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ethyl during diff'!$A$5</c:f>
              <c:strCache>
                <c:ptCount val="1"/>
                <c:pt idx="0">
                  <c:v>H3K9me1 (8.8E-13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5:$F$5</c:f>
              <c:numCache>
                <c:formatCode>General</c:formatCode>
                <c:ptCount val="5"/>
                <c:pt idx="0">
                  <c:v>0.23260383333333301</c:v>
                </c:pt>
                <c:pt idx="1">
                  <c:v>0.205343833333333</c:v>
                </c:pt>
                <c:pt idx="2">
                  <c:v>0.188944</c:v>
                </c:pt>
                <c:pt idx="3">
                  <c:v>0.17873749999999999</c:v>
                </c:pt>
                <c:pt idx="4">
                  <c:v>0.17584050000000001</c:v>
                </c:pt>
              </c:numCache>
            </c:numRef>
          </c:val>
        </c:ser>
        <c:ser>
          <c:idx val="1"/>
          <c:order val="1"/>
          <c:tx>
            <c:strRef>
              <c:f>'Methyl during diff'!$A$6</c:f>
              <c:strCache>
                <c:ptCount val="1"/>
                <c:pt idx="0">
                  <c:v>H3K9me2 (5.6E-10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6:$F$6</c:f>
              <c:numCache>
                <c:formatCode>General</c:formatCode>
                <c:ptCount val="5"/>
                <c:pt idx="0">
                  <c:v>0.30584899999999998</c:v>
                </c:pt>
                <c:pt idx="1">
                  <c:v>0.39658083333333299</c:v>
                </c:pt>
                <c:pt idx="2">
                  <c:v>0.376187833333333</c:v>
                </c:pt>
                <c:pt idx="3">
                  <c:v>0.38335866666666701</c:v>
                </c:pt>
                <c:pt idx="4">
                  <c:v>0.38802566666666699</c:v>
                </c:pt>
              </c:numCache>
            </c:numRef>
          </c:val>
        </c:ser>
        <c:ser>
          <c:idx val="2"/>
          <c:order val="2"/>
          <c:tx>
            <c:strRef>
              <c:f>'Methyl during diff'!$A$7</c:f>
              <c:strCache>
                <c:ptCount val="1"/>
                <c:pt idx="0">
                  <c:v>H3K9me3 (5.45E-10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7:$F$7</c:f>
              <c:numCache>
                <c:formatCode>General</c:formatCode>
                <c:ptCount val="5"/>
                <c:pt idx="0">
                  <c:v>0.14023099999999999</c:v>
                </c:pt>
                <c:pt idx="1">
                  <c:v>0.20357983333333299</c:v>
                </c:pt>
                <c:pt idx="2">
                  <c:v>0.22048833333333301</c:v>
                </c:pt>
                <c:pt idx="3">
                  <c:v>0.25055833333333299</c:v>
                </c:pt>
                <c:pt idx="4">
                  <c:v>0.266631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4596224"/>
        <c:axId val="84597760"/>
      </c:barChart>
      <c:catAx>
        <c:axId val="84596224"/>
        <c:scaling>
          <c:orientation val="minMax"/>
        </c:scaling>
        <c:delete val="0"/>
        <c:axPos val="b"/>
        <c:majorTickMark val="out"/>
        <c:minorTickMark val="none"/>
        <c:tickLblPos val="nextTo"/>
        <c:crossAx val="84597760"/>
        <c:crosses val="autoZero"/>
        <c:auto val="1"/>
        <c:lblAlgn val="ctr"/>
        <c:lblOffset val="100"/>
        <c:noMultiLvlLbl val="0"/>
      </c:catAx>
      <c:valAx>
        <c:axId val="84597760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%" sourceLinked="0"/>
        <c:majorTickMark val="out"/>
        <c:minorTickMark val="none"/>
        <c:tickLblPos val="nextTo"/>
        <c:crossAx val="84596224"/>
        <c:crosses val="autoZero"/>
        <c:crossBetween val="between"/>
        <c:majorUnit val="0.15"/>
      </c:valAx>
      <c:spPr>
        <a:noFill/>
      </c:spPr>
    </c:plotArea>
    <c:legend>
      <c:legendPos val="t"/>
      <c:layout/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5"/>
    </mc:Choice>
    <mc:Fallback>
      <c:style val="35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ethyl during diff'!$A$2</c:f>
              <c:strCache>
                <c:ptCount val="1"/>
                <c:pt idx="0">
                  <c:v>H3K4me1 (1.6E-05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2:$F$2</c:f>
              <c:numCache>
                <c:formatCode>General</c:formatCode>
                <c:ptCount val="5"/>
                <c:pt idx="0">
                  <c:v>0.17153083333333299</c:v>
                </c:pt>
                <c:pt idx="1">
                  <c:v>0.13972399999999999</c:v>
                </c:pt>
                <c:pt idx="2">
                  <c:v>0.133034666666667</c:v>
                </c:pt>
                <c:pt idx="3">
                  <c:v>0.12583583333333301</c:v>
                </c:pt>
                <c:pt idx="4">
                  <c:v>0.13005766666666699</c:v>
                </c:pt>
              </c:numCache>
            </c:numRef>
          </c:val>
        </c:ser>
        <c:ser>
          <c:idx val="1"/>
          <c:order val="1"/>
          <c:tx>
            <c:strRef>
              <c:f>'Methyl during diff'!$A$3</c:f>
              <c:strCache>
                <c:ptCount val="1"/>
                <c:pt idx="0">
                  <c:v>H3K4me2 (1.06E-01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3:$F$3</c:f>
              <c:numCache>
                <c:formatCode>General</c:formatCode>
                <c:ptCount val="5"/>
                <c:pt idx="0">
                  <c:v>1.6206166666666699E-2</c:v>
                </c:pt>
                <c:pt idx="1">
                  <c:v>1.6195000000000001E-2</c:v>
                </c:pt>
                <c:pt idx="2">
                  <c:v>1.0595833333333299E-2</c:v>
                </c:pt>
                <c:pt idx="3">
                  <c:v>1.08843333333333E-2</c:v>
                </c:pt>
                <c:pt idx="4">
                  <c:v>1.2696499999999999E-2</c:v>
                </c:pt>
              </c:numCache>
            </c:numRef>
          </c:val>
        </c:ser>
        <c:ser>
          <c:idx val="2"/>
          <c:order val="2"/>
          <c:tx>
            <c:strRef>
              <c:f>'Methyl during diff'!$A$4</c:f>
              <c:strCache>
                <c:ptCount val="1"/>
                <c:pt idx="0">
                  <c:v>H3K4me3 (3.3E-01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4:$F$4</c:f>
              <c:numCache>
                <c:formatCode>General</c:formatCode>
                <c:ptCount val="5"/>
                <c:pt idx="0">
                  <c:v>3.7143333333333299E-3</c:v>
                </c:pt>
                <c:pt idx="1">
                  <c:v>6.1201666666666696E-3</c:v>
                </c:pt>
                <c:pt idx="2">
                  <c:v>5.1191666666666703E-3</c:v>
                </c:pt>
                <c:pt idx="3">
                  <c:v>4.7061666666666701E-3</c:v>
                </c:pt>
                <c:pt idx="4">
                  <c:v>5.6771666666666698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95314304"/>
        <c:axId val="95315840"/>
      </c:barChart>
      <c:catAx>
        <c:axId val="95314304"/>
        <c:scaling>
          <c:orientation val="minMax"/>
        </c:scaling>
        <c:delete val="0"/>
        <c:axPos val="b"/>
        <c:majorTickMark val="out"/>
        <c:minorTickMark val="none"/>
        <c:tickLblPos val="nextTo"/>
        <c:crossAx val="95315840"/>
        <c:crosses val="autoZero"/>
        <c:auto val="1"/>
        <c:lblAlgn val="ctr"/>
        <c:lblOffset val="100"/>
        <c:noMultiLvlLbl val="0"/>
      </c:catAx>
      <c:valAx>
        <c:axId val="95315840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%" sourceLinked="0"/>
        <c:majorTickMark val="out"/>
        <c:minorTickMark val="none"/>
        <c:tickLblPos val="nextTo"/>
        <c:crossAx val="95314304"/>
        <c:crosses val="autoZero"/>
        <c:crossBetween val="between"/>
      </c:valAx>
      <c:spPr>
        <a:noFill/>
      </c:spPr>
    </c:plotArea>
    <c:legend>
      <c:legendPos val="t"/>
      <c:layout/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5"/>
    </mc:Choice>
    <mc:Fallback>
      <c:style val="35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ethyl during diff'!$A$11</c:f>
              <c:strCache>
                <c:ptCount val="1"/>
                <c:pt idx="0">
                  <c:v>H3K27me1 (9.0E-23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11:$F$11</c:f>
              <c:numCache>
                <c:formatCode>General</c:formatCode>
                <c:ptCount val="5"/>
                <c:pt idx="0">
                  <c:v>0.15259700000000001</c:v>
                </c:pt>
                <c:pt idx="1">
                  <c:v>0.29226849999999999</c:v>
                </c:pt>
                <c:pt idx="2">
                  <c:v>0.2989</c:v>
                </c:pt>
                <c:pt idx="3">
                  <c:v>0.30895983333333299</c:v>
                </c:pt>
                <c:pt idx="4">
                  <c:v>0.30404483333333299</c:v>
                </c:pt>
              </c:numCache>
            </c:numRef>
          </c:val>
        </c:ser>
        <c:ser>
          <c:idx val="1"/>
          <c:order val="1"/>
          <c:tx>
            <c:strRef>
              <c:f>'Methyl during diff'!$A$12</c:f>
              <c:strCache>
                <c:ptCount val="1"/>
                <c:pt idx="0">
                  <c:v>H3K27me2 (1.1E-10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12:$F$12</c:f>
              <c:numCache>
                <c:formatCode>General</c:formatCode>
                <c:ptCount val="5"/>
                <c:pt idx="0">
                  <c:v>0.52211466666666695</c:v>
                </c:pt>
                <c:pt idx="1">
                  <c:v>0.44662366666666697</c:v>
                </c:pt>
                <c:pt idx="2">
                  <c:v>0.432383666666667</c:v>
                </c:pt>
                <c:pt idx="3">
                  <c:v>0.42512216666666702</c:v>
                </c:pt>
                <c:pt idx="4">
                  <c:v>0.4443105</c:v>
                </c:pt>
              </c:numCache>
            </c:numRef>
          </c:val>
        </c:ser>
        <c:ser>
          <c:idx val="2"/>
          <c:order val="2"/>
          <c:tx>
            <c:strRef>
              <c:f>'Methyl during diff'!$A$13</c:f>
              <c:strCache>
                <c:ptCount val="1"/>
                <c:pt idx="0">
                  <c:v>H3K27me3 (7.8E-26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13:$F$13</c:f>
              <c:numCache>
                <c:formatCode>General</c:formatCode>
                <c:ptCount val="5"/>
                <c:pt idx="0">
                  <c:v>0.25917166666666702</c:v>
                </c:pt>
                <c:pt idx="1">
                  <c:v>8.9936500000000003E-2</c:v>
                </c:pt>
                <c:pt idx="2">
                  <c:v>5.7446333333333301E-2</c:v>
                </c:pt>
                <c:pt idx="3">
                  <c:v>5.5586999999999998E-2</c:v>
                </c:pt>
                <c:pt idx="4">
                  <c:v>7.057616666666670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95345664"/>
        <c:axId val="95351552"/>
      </c:barChart>
      <c:catAx>
        <c:axId val="95345664"/>
        <c:scaling>
          <c:orientation val="minMax"/>
        </c:scaling>
        <c:delete val="0"/>
        <c:axPos val="b"/>
        <c:majorTickMark val="out"/>
        <c:minorTickMark val="none"/>
        <c:tickLblPos val="nextTo"/>
        <c:crossAx val="95351552"/>
        <c:crosses val="autoZero"/>
        <c:auto val="1"/>
        <c:lblAlgn val="ctr"/>
        <c:lblOffset val="100"/>
        <c:noMultiLvlLbl val="0"/>
      </c:catAx>
      <c:valAx>
        <c:axId val="95351552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%" sourceLinked="0"/>
        <c:majorTickMark val="out"/>
        <c:minorTickMark val="none"/>
        <c:tickLblPos val="nextTo"/>
        <c:crossAx val="95345664"/>
        <c:crosses val="autoZero"/>
        <c:crossBetween val="between"/>
        <c:majorUnit val="0.2"/>
      </c:valAx>
      <c:spPr>
        <a:noFill/>
      </c:spPr>
    </c:plotArea>
    <c:legend>
      <c:legendPos val="t"/>
      <c:layout/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5"/>
    </mc:Choice>
    <mc:Fallback>
      <c:style val="35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Methyl during diff'!$A$14</c:f>
              <c:strCache>
                <c:ptCount val="1"/>
                <c:pt idx="0">
                  <c:v>H3K36me1 (1.0E-04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14:$F$14</c:f>
              <c:numCache>
                <c:formatCode>General</c:formatCode>
                <c:ptCount val="5"/>
                <c:pt idx="0">
                  <c:v>0.30377100000000001</c:v>
                </c:pt>
                <c:pt idx="1">
                  <c:v>0.26776883333333301</c:v>
                </c:pt>
                <c:pt idx="2">
                  <c:v>0.284057</c:v>
                </c:pt>
                <c:pt idx="3">
                  <c:v>0.27917716666666698</c:v>
                </c:pt>
                <c:pt idx="4">
                  <c:v>0.27223583333333301</c:v>
                </c:pt>
              </c:numCache>
            </c:numRef>
          </c:val>
        </c:ser>
        <c:ser>
          <c:idx val="1"/>
          <c:order val="1"/>
          <c:tx>
            <c:strRef>
              <c:f>'Methyl during diff'!$A$15</c:f>
              <c:strCache>
                <c:ptCount val="1"/>
                <c:pt idx="0">
                  <c:v>H3K36me2 (2.8E-10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15:$F$15</c:f>
              <c:numCache>
                <c:formatCode>General</c:formatCode>
                <c:ptCount val="5"/>
                <c:pt idx="0">
                  <c:v>0.30790483333333302</c:v>
                </c:pt>
                <c:pt idx="1">
                  <c:v>0.44401733333333299</c:v>
                </c:pt>
                <c:pt idx="2">
                  <c:v>0.38383016666666703</c:v>
                </c:pt>
                <c:pt idx="3">
                  <c:v>0.37069416666666699</c:v>
                </c:pt>
                <c:pt idx="4">
                  <c:v>0.36980200000000002</c:v>
                </c:pt>
              </c:numCache>
            </c:numRef>
          </c:val>
        </c:ser>
        <c:ser>
          <c:idx val="2"/>
          <c:order val="2"/>
          <c:tx>
            <c:strRef>
              <c:f>'Methyl during diff'!$A$16</c:f>
              <c:strCache>
                <c:ptCount val="1"/>
                <c:pt idx="0">
                  <c:v>H3K36me3 (6.9E-11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Methyl during diff'!$B$1:$F$1</c:f>
              <c:strCache>
                <c:ptCount val="5"/>
                <c:pt idx="0">
                  <c:v>ESCs</c:v>
                </c:pt>
                <c:pt idx="1">
                  <c:v>EBs</c:v>
                </c:pt>
                <c:pt idx="2">
                  <c:v>1d RA</c:v>
                </c:pt>
                <c:pt idx="3">
                  <c:v>4d RA</c:v>
                </c:pt>
                <c:pt idx="4">
                  <c:v>7d RA</c:v>
                </c:pt>
              </c:strCache>
            </c:strRef>
          </c:cat>
          <c:val>
            <c:numRef>
              <c:f>'Methyl during diff'!$B$16:$F$16</c:f>
              <c:numCache>
                <c:formatCode>General</c:formatCode>
                <c:ptCount val="5"/>
                <c:pt idx="0">
                  <c:v>1.8315833333333299E-2</c:v>
                </c:pt>
                <c:pt idx="1">
                  <c:v>1.29213333333333E-2</c:v>
                </c:pt>
                <c:pt idx="2">
                  <c:v>1.68395E-2</c:v>
                </c:pt>
                <c:pt idx="3">
                  <c:v>2.05928333333333E-2</c:v>
                </c:pt>
                <c:pt idx="4">
                  <c:v>2.393249999999999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95512448"/>
        <c:axId val="95513984"/>
      </c:barChart>
      <c:catAx>
        <c:axId val="95512448"/>
        <c:scaling>
          <c:orientation val="minMax"/>
        </c:scaling>
        <c:delete val="0"/>
        <c:axPos val="b"/>
        <c:majorTickMark val="out"/>
        <c:minorTickMark val="none"/>
        <c:tickLblPos val="nextTo"/>
        <c:crossAx val="95513984"/>
        <c:crosses val="autoZero"/>
        <c:auto val="1"/>
        <c:lblAlgn val="ctr"/>
        <c:lblOffset val="100"/>
        <c:noMultiLvlLbl val="0"/>
      </c:catAx>
      <c:valAx>
        <c:axId val="95513984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%" sourceLinked="0"/>
        <c:majorTickMark val="out"/>
        <c:minorTickMark val="none"/>
        <c:tickLblPos val="nextTo"/>
        <c:crossAx val="95512448"/>
        <c:crosses val="autoZero"/>
        <c:crossBetween val="between"/>
      </c:valAx>
      <c:spPr>
        <a:noFill/>
      </c:spPr>
    </c:plotArea>
    <c:legend>
      <c:legendPos val="t"/>
      <c:layout/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9"/>
    </mc:Choice>
    <mc:Fallback>
      <c:style val="39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cetyl during diff'!$B$1</c:f>
              <c:strCache>
                <c:ptCount val="1"/>
                <c:pt idx="0">
                  <c:v>ESC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Acetyl during diff'!$A$2:$A$9</c:f>
              <c:strCache>
                <c:ptCount val="8"/>
                <c:pt idx="0">
                  <c:v>H3K23ac</c:v>
                </c:pt>
                <c:pt idx="1">
                  <c:v>H4K8ac</c:v>
                </c:pt>
                <c:pt idx="2">
                  <c:v>H4K12ac</c:v>
                </c:pt>
                <c:pt idx="3">
                  <c:v>H4K5ac</c:v>
                </c:pt>
                <c:pt idx="4">
                  <c:v>H3K18ac</c:v>
                </c:pt>
                <c:pt idx="5">
                  <c:v>H3K9ac</c:v>
                </c:pt>
                <c:pt idx="6">
                  <c:v>H3K14ac</c:v>
                </c:pt>
                <c:pt idx="7">
                  <c:v>H4K16ac</c:v>
                </c:pt>
              </c:strCache>
            </c:strRef>
          </c:cat>
          <c:val>
            <c:numRef>
              <c:f>'Acetyl during diff'!$B$2:$B$9</c:f>
              <c:numCache>
                <c:formatCode>0.0%</c:formatCode>
                <c:ptCount val="8"/>
                <c:pt idx="0">
                  <c:v>0.33233633333333301</c:v>
                </c:pt>
                <c:pt idx="1">
                  <c:v>0.13152566666666701</c:v>
                </c:pt>
                <c:pt idx="2">
                  <c:v>0.20867949999999999</c:v>
                </c:pt>
                <c:pt idx="3">
                  <c:v>8.5526666666666695E-2</c:v>
                </c:pt>
                <c:pt idx="4">
                  <c:v>8.7374499999999994E-2</c:v>
                </c:pt>
                <c:pt idx="5">
                  <c:v>1.3520000000000001E-2</c:v>
                </c:pt>
                <c:pt idx="6">
                  <c:v>0.37446000000000002</c:v>
                </c:pt>
                <c:pt idx="7">
                  <c:v>0.304367833333333</c:v>
                </c:pt>
              </c:numCache>
            </c:numRef>
          </c:val>
        </c:ser>
        <c:ser>
          <c:idx val="1"/>
          <c:order val="1"/>
          <c:tx>
            <c:strRef>
              <c:f>'Acetyl during diff'!$C$1</c:f>
              <c:strCache>
                <c:ptCount val="1"/>
                <c:pt idx="0">
                  <c:v>EBs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Acetyl during diff'!$A$2:$A$9</c:f>
              <c:strCache>
                <c:ptCount val="8"/>
                <c:pt idx="0">
                  <c:v>H3K23ac</c:v>
                </c:pt>
                <c:pt idx="1">
                  <c:v>H4K8ac</c:v>
                </c:pt>
                <c:pt idx="2">
                  <c:v>H4K12ac</c:v>
                </c:pt>
                <c:pt idx="3">
                  <c:v>H4K5ac</c:v>
                </c:pt>
                <c:pt idx="4">
                  <c:v>H3K18ac</c:v>
                </c:pt>
                <c:pt idx="5">
                  <c:v>H3K9ac</c:v>
                </c:pt>
                <c:pt idx="6">
                  <c:v>H3K14ac</c:v>
                </c:pt>
                <c:pt idx="7">
                  <c:v>H4K16ac</c:v>
                </c:pt>
              </c:strCache>
            </c:strRef>
          </c:cat>
          <c:val>
            <c:numRef>
              <c:f>'Acetyl during diff'!$C$2:$C$9</c:f>
              <c:numCache>
                <c:formatCode>0.0%</c:formatCode>
                <c:ptCount val="8"/>
                <c:pt idx="0">
                  <c:v>0.44556333333333298</c:v>
                </c:pt>
                <c:pt idx="1">
                  <c:v>0.11955866666666699</c:v>
                </c:pt>
                <c:pt idx="2">
                  <c:v>0.216775</c:v>
                </c:pt>
                <c:pt idx="3">
                  <c:v>7.8839000000000006E-2</c:v>
                </c:pt>
                <c:pt idx="4">
                  <c:v>0.135824</c:v>
                </c:pt>
                <c:pt idx="5">
                  <c:v>1.5955833333333301E-2</c:v>
                </c:pt>
                <c:pt idx="6">
                  <c:v>0.42879666666666699</c:v>
                </c:pt>
                <c:pt idx="7">
                  <c:v>0.45586633333333298</c:v>
                </c:pt>
              </c:numCache>
            </c:numRef>
          </c:val>
        </c:ser>
        <c:ser>
          <c:idx val="2"/>
          <c:order val="2"/>
          <c:tx>
            <c:strRef>
              <c:f>'Acetyl during diff'!$D$1</c:f>
              <c:strCache>
                <c:ptCount val="1"/>
                <c:pt idx="0">
                  <c:v>1d RA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Acetyl during diff'!$A$2:$A$9</c:f>
              <c:strCache>
                <c:ptCount val="8"/>
                <c:pt idx="0">
                  <c:v>H3K23ac</c:v>
                </c:pt>
                <c:pt idx="1">
                  <c:v>H4K8ac</c:v>
                </c:pt>
                <c:pt idx="2">
                  <c:v>H4K12ac</c:v>
                </c:pt>
                <c:pt idx="3">
                  <c:v>H4K5ac</c:v>
                </c:pt>
                <c:pt idx="4">
                  <c:v>H3K18ac</c:v>
                </c:pt>
                <c:pt idx="5">
                  <c:v>H3K9ac</c:v>
                </c:pt>
                <c:pt idx="6">
                  <c:v>H3K14ac</c:v>
                </c:pt>
                <c:pt idx="7">
                  <c:v>H4K16ac</c:v>
                </c:pt>
              </c:strCache>
            </c:strRef>
          </c:cat>
          <c:val>
            <c:numRef>
              <c:f>'Acetyl during diff'!$D$2:$D$9</c:f>
              <c:numCache>
                <c:formatCode>0.0%</c:formatCode>
                <c:ptCount val="8"/>
                <c:pt idx="0">
                  <c:v>0.392688166666667</c:v>
                </c:pt>
                <c:pt idx="1">
                  <c:v>0.1175325</c:v>
                </c:pt>
                <c:pt idx="2">
                  <c:v>0.17701266666666701</c:v>
                </c:pt>
                <c:pt idx="3">
                  <c:v>9.6901666666666705E-2</c:v>
                </c:pt>
                <c:pt idx="4">
                  <c:v>0.11893933333333299</c:v>
                </c:pt>
                <c:pt idx="5">
                  <c:v>1.62045E-2</c:v>
                </c:pt>
                <c:pt idx="6">
                  <c:v>0.45613999999999999</c:v>
                </c:pt>
                <c:pt idx="7">
                  <c:v>0.536948166666667</c:v>
                </c:pt>
              </c:numCache>
            </c:numRef>
          </c:val>
        </c:ser>
        <c:ser>
          <c:idx val="3"/>
          <c:order val="3"/>
          <c:tx>
            <c:strRef>
              <c:f>'Acetyl during diff'!$E$1</c:f>
              <c:strCache>
                <c:ptCount val="1"/>
                <c:pt idx="0">
                  <c:v>4d RA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Acetyl during diff'!$A$2:$A$9</c:f>
              <c:strCache>
                <c:ptCount val="8"/>
                <c:pt idx="0">
                  <c:v>H3K23ac</c:v>
                </c:pt>
                <c:pt idx="1">
                  <c:v>H4K8ac</c:v>
                </c:pt>
                <c:pt idx="2">
                  <c:v>H4K12ac</c:v>
                </c:pt>
                <c:pt idx="3">
                  <c:v>H4K5ac</c:v>
                </c:pt>
                <c:pt idx="4">
                  <c:v>H3K18ac</c:v>
                </c:pt>
                <c:pt idx="5">
                  <c:v>H3K9ac</c:v>
                </c:pt>
                <c:pt idx="6">
                  <c:v>H3K14ac</c:v>
                </c:pt>
                <c:pt idx="7">
                  <c:v>H4K16ac</c:v>
                </c:pt>
              </c:strCache>
            </c:strRef>
          </c:cat>
          <c:val>
            <c:numRef>
              <c:f>'Acetyl during diff'!$E$2:$E$9</c:f>
              <c:numCache>
                <c:formatCode>0.0%</c:formatCode>
                <c:ptCount val="8"/>
                <c:pt idx="0">
                  <c:v>0.28131366666666702</c:v>
                </c:pt>
                <c:pt idx="1">
                  <c:v>6.3774333333333294E-2</c:v>
                </c:pt>
                <c:pt idx="2">
                  <c:v>9.7703333333333295E-2</c:v>
                </c:pt>
                <c:pt idx="3">
                  <c:v>4.6822999999999997E-2</c:v>
                </c:pt>
                <c:pt idx="4">
                  <c:v>8.3972166666666695E-2</c:v>
                </c:pt>
                <c:pt idx="5">
                  <c:v>7.6930000000000002E-3</c:v>
                </c:pt>
                <c:pt idx="6">
                  <c:v>0.45292466666666698</c:v>
                </c:pt>
                <c:pt idx="7">
                  <c:v>0.45740183333333301</c:v>
                </c:pt>
              </c:numCache>
            </c:numRef>
          </c:val>
        </c:ser>
        <c:ser>
          <c:idx val="4"/>
          <c:order val="4"/>
          <c:tx>
            <c:strRef>
              <c:f>'Acetyl during diff'!$F$1</c:f>
              <c:strCache>
                <c:ptCount val="1"/>
                <c:pt idx="0">
                  <c:v>7d RA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cat>
            <c:strRef>
              <c:f>'Acetyl during diff'!$A$2:$A$9</c:f>
              <c:strCache>
                <c:ptCount val="8"/>
                <c:pt idx="0">
                  <c:v>H3K23ac</c:v>
                </c:pt>
                <c:pt idx="1">
                  <c:v>H4K8ac</c:v>
                </c:pt>
                <c:pt idx="2">
                  <c:v>H4K12ac</c:v>
                </c:pt>
                <c:pt idx="3">
                  <c:v>H4K5ac</c:v>
                </c:pt>
                <c:pt idx="4">
                  <c:v>H3K18ac</c:v>
                </c:pt>
                <c:pt idx="5">
                  <c:v>H3K9ac</c:v>
                </c:pt>
                <c:pt idx="6">
                  <c:v>H3K14ac</c:v>
                </c:pt>
                <c:pt idx="7">
                  <c:v>H4K16ac</c:v>
                </c:pt>
              </c:strCache>
            </c:strRef>
          </c:cat>
          <c:val>
            <c:numRef>
              <c:f>'Acetyl during diff'!$F$2:$F$9</c:f>
              <c:numCache>
                <c:formatCode>0.0%</c:formatCode>
                <c:ptCount val="8"/>
                <c:pt idx="0">
                  <c:v>0.259033333333333</c:v>
                </c:pt>
                <c:pt idx="1">
                  <c:v>5.2847999999999999E-2</c:v>
                </c:pt>
                <c:pt idx="2">
                  <c:v>7.8426499999999996E-2</c:v>
                </c:pt>
                <c:pt idx="3">
                  <c:v>3.90485E-2</c:v>
                </c:pt>
                <c:pt idx="4">
                  <c:v>6.5979833333333293E-2</c:v>
                </c:pt>
                <c:pt idx="5">
                  <c:v>7.4795E-3</c:v>
                </c:pt>
                <c:pt idx="6">
                  <c:v>0.41208616666666698</c:v>
                </c:pt>
                <c:pt idx="7">
                  <c:v>0.448101166666666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20"/>
        <c:axId val="95619328"/>
        <c:axId val="95633408"/>
      </c:barChart>
      <c:catAx>
        <c:axId val="95619328"/>
        <c:scaling>
          <c:orientation val="minMax"/>
        </c:scaling>
        <c:delete val="0"/>
        <c:axPos val="b"/>
        <c:majorTickMark val="out"/>
        <c:minorTickMark val="none"/>
        <c:tickLblPos val="nextTo"/>
        <c:crossAx val="95633408"/>
        <c:crosses val="autoZero"/>
        <c:auto val="1"/>
        <c:lblAlgn val="ctr"/>
        <c:lblOffset val="100"/>
        <c:noMultiLvlLbl val="0"/>
      </c:catAx>
      <c:valAx>
        <c:axId val="95633408"/>
        <c:scaling>
          <c:orientation val="minMax"/>
        </c:scaling>
        <c:delete val="0"/>
        <c:axPos val="l"/>
        <c:majorGridlines/>
        <c:numFmt formatCode="0%" sourceLinked="0"/>
        <c:majorTickMark val="out"/>
        <c:minorTickMark val="none"/>
        <c:tickLblPos val="nextTo"/>
        <c:crossAx val="95619328"/>
        <c:crosses val="autoZero"/>
        <c:crossBetween val="between"/>
      </c:valAx>
      <c:spPr>
        <a:noFill/>
      </c:spPr>
    </c:plotArea>
    <c:legend>
      <c:legendPos val="t"/>
      <c:layout/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>
              <a:solidFill>
                <a:schemeClr val="accent6">
                  <a:lumMod val="75000"/>
                  <a:alpha val="50000"/>
                </a:schemeClr>
              </a:solidFill>
            </a:ln>
          </c:spPr>
          <c:marker>
            <c:symbol val="none"/>
          </c:marker>
          <c:dLbls>
            <c:numFmt formatCode="#,##0.0" sourceLinked="0"/>
            <c:spPr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/>
              <a:lstStyle/>
              <a:p>
                <a:pPr>
                  <a:defRPr>
                    <a:solidFill>
                      <a:schemeClr val="accent6">
                        <a:lumMod val="50000"/>
                      </a:schemeClr>
                    </a:solidFill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val>
            <c:numRef>
              <c:f>'Acetyl during diff'!$I$2:$I$9</c:f>
              <c:numCache>
                <c:formatCode>General</c:formatCode>
                <c:ptCount val="8"/>
                <c:pt idx="0">
                  <c:v>14.053590326404031</c:v>
                </c:pt>
                <c:pt idx="1">
                  <c:v>13.651158569538151</c:v>
                </c:pt>
                <c:pt idx="2">
                  <c:v>13.605597049312831</c:v>
                </c:pt>
                <c:pt idx="3">
                  <c:v>12.6174795056378</c:v>
                </c:pt>
                <c:pt idx="4">
                  <c:v>9.5734135602918276</c:v>
                </c:pt>
                <c:pt idx="5">
                  <c:v>9.1383618071489678</c:v>
                </c:pt>
                <c:pt idx="6">
                  <c:v>6.6576718402592032</c:v>
                </c:pt>
                <c:pt idx="7">
                  <c:v>6.535029740595655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5657984"/>
        <c:axId val="95659520"/>
      </c:lineChart>
      <c:catAx>
        <c:axId val="95657984"/>
        <c:scaling>
          <c:orientation val="minMax"/>
        </c:scaling>
        <c:delete val="0"/>
        <c:axPos val="b"/>
        <c:majorTickMark val="none"/>
        <c:minorTickMark val="none"/>
        <c:tickLblPos val="none"/>
        <c:crossAx val="95659520"/>
        <c:crosses val="autoZero"/>
        <c:auto val="1"/>
        <c:lblAlgn val="ctr"/>
        <c:lblOffset val="100"/>
        <c:noMultiLvlLbl val="0"/>
      </c:catAx>
      <c:valAx>
        <c:axId val="95659520"/>
        <c:scaling>
          <c:orientation val="minMax"/>
          <c:max val="18"/>
        </c:scaling>
        <c:delete val="0"/>
        <c:axPos val="l"/>
        <c:numFmt formatCode="General" sourceLinked="1"/>
        <c:majorTickMark val="none"/>
        <c:minorTickMark val="none"/>
        <c:tickLblPos val="high"/>
        <c:crossAx val="95657984"/>
        <c:crosses val="autoZero"/>
        <c:crossBetween val="between"/>
        <c:majorUnit val="3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4586</cdr:x>
      <cdr:y>0.52778</cdr:y>
    </cdr:from>
    <cdr:to>
      <cdr:x>0.62029</cdr:x>
      <cdr:y>0.55556</cdr:y>
    </cdr:to>
    <cdr:cxnSp macro="">
      <cdr:nvCxnSpPr>
        <cdr:cNvPr id="3" name="Straight Connector 2"/>
        <cdr:cNvCxnSpPr/>
      </cdr:nvCxnSpPr>
      <cdr:spPr>
        <a:xfrm xmlns:a="http://schemas.openxmlformats.org/drawingml/2006/main" flipV="1">
          <a:off x="1676400" y="1447800"/>
          <a:ext cx="228600" cy="762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451</cdr:x>
      <cdr:y>0.5</cdr:y>
    </cdr:from>
    <cdr:to>
      <cdr:x>0.71954</cdr:x>
      <cdr:y>0.55556</cdr:y>
    </cdr:to>
    <cdr:cxnSp macro="">
      <cdr:nvCxnSpPr>
        <cdr:cNvPr id="5" name="Straight Connector 4"/>
        <cdr:cNvCxnSpPr/>
      </cdr:nvCxnSpPr>
      <cdr:spPr>
        <a:xfrm xmlns:a="http://schemas.openxmlformats.org/drawingml/2006/main">
          <a:off x="1981200" y="1371600"/>
          <a:ext cx="228600" cy="15240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93D4DE-A6B5-4475-8CE9-82A50DB52F3A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1C6B31-AAEC-4CBF-8CF1-C3A3D3ADCA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6360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Figure S1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1C6B31-AAEC-4CBF-8CF1-C3A3D3ADCA2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572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0598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037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575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933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63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111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6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5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203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993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206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7D5B0-D26E-4E6E-B604-F0737FDA10E1}" type="datetimeFigureOut">
              <a:rPr lang="en-US" smtClean="0"/>
              <a:t>9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3508E-CC18-4CD1-8B84-39D74837B0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256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Oval 28"/>
          <p:cNvSpPr/>
          <p:nvPr/>
        </p:nvSpPr>
        <p:spPr>
          <a:xfrm rot="256664">
            <a:off x="2358400" y="542482"/>
            <a:ext cx="1455584" cy="413502"/>
          </a:xfrm>
          <a:prstGeom prst="ellipse">
            <a:avLst/>
          </a:prstGeom>
          <a:solidFill>
            <a:schemeClr val="accent1">
              <a:lumMod val="40000"/>
              <a:lumOff val="60000"/>
              <a:alpha val="2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Oval 33"/>
          <p:cNvSpPr/>
          <p:nvPr/>
        </p:nvSpPr>
        <p:spPr>
          <a:xfrm rot="19903957">
            <a:off x="1105534" y="606953"/>
            <a:ext cx="872178" cy="578052"/>
          </a:xfrm>
          <a:prstGeom prst="ellipse">
            <a:avLst/>
          </a:prstGeom>
          <a:solidFill>
            <a:srgbClr val="FFC000">
              <a:alpha val="25000"/>
            </a:srgb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9736374"/>
              </p:ext>
            </p:extLst>
          </p:nvPr>
        </p:nvGraphicFramePr>
        <p:xfrm>
          <a:off x="609600" y="0"/>
          <a:ext cx="3657600" cy="24470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9" name="Straight Connector 38"/>
          <p:cNvCxnSpPr/>
          <p:nvPr/>
        </p:nvCxnSpPr>
        <p:spPr>
          <a:xfrm>
            <a:off x="1020938" y="2146176"/>
            <a:ext cx="2514600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 flipV="1">
            <a:off x="1020938" y="152400"/>
            <a:ext cx="0" cy="199377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0" y="-25313"/>
            <a:ext cx="678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A)</a:t>
            </a:r>
            <a:endParaRPr 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54" name="Chart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9168922"/>
              </p:ext>
            </p:extLst>
          </p:nvPr>
        </p:nvGraphicFramePr>
        <p:xfrm>
          <a:off x="7736966" y="381000"/>
          <a:ext cx="2121408" cy="22841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5" name="Chart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8680582"/>
              </p:ext>
            </p:extLst>
          </p:nvPr>
        </p:nvGraphicFramePr>
        <p:xfrm>
          <a:off x="5586483" y="381000"/>
          <a:ext cx="2124075" cy="22841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6" name="Chart 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1785073"/>
              </p:ext>
            </p:extLst>
          </p:nvPr>
        </p:nvGraphicFramePr>
        <p:xfrm>
          <a:off x="5587816" y="3124200"/>
          <a:ext cx="2121408" cy="22841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57" name="Chart 5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2234356"/>
              </p:ext>
            </p:extLst>
          </p:nvPr>
        </p:nvGraphicFramePr>
        <p:xfrm>
          <a:off x="7736966" y="3124200"/>
          <a:ext cx="2121408" cy="22841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8" name="TextBox 57"/>
          <p:cNvSpPr txBox="1"/>
          <p:nvPr/>
        </p:nvSpPr>
        <p:spPr>
          <a:xfrm>
            <a:off x="5181600" y="-25313"/>
            <a:ext cx="678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B)</a:t>
            </a:r>
            <a:endParaRPr 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4813970" y="1589007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el. abundance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4813970" y="4340992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el. abundance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802922" y="2327738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mponent 1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-151720" y="1026177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omponent 2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0" y="2895600"/>
            <a:ext cx="678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C)</a:t>
            </a:r>
            <a:endParaRPr lang="en-US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65" name="Chart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5977693"/>
              </p:ext>
            </p:extLst>
          </p:nvPr>
        </p:nvGraphicFramePr>
        <p:xfrm>
          <a:off x="376400" y="3032880"/>
          <a:ext cx="4398870" cy="2799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6" name="TextBox 65"/>
          <p:cNvSpPr txBox="1"/>
          <p:nvPr/>
        </p:nvSpPr>
        <p:spPr>
          <a:xfrm rot="16200000">
            <a:off x="-384881" y="4198322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Rel. abundance</a:t>
            </a:r>
            <a:endParaRPr lang="en-US" sz="10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5400000">
            <a:off x="4085337" y="4198322"/>
            <a:ext cx="18288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 smtClean="0">
                <a:solidFill>
                  <a:schemeClr val="accent6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Log10 ANOVA p-value</a:t>
            </a:r>
            <a:endParaRPr lang="en-US" sz="1000" i="1" dirty="0">
              <a:solidFill>
                <a:schemeClr val="accent6">
                  <a:lumMod val="75000"/>
                </a:schemeClr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3771958" y="4463806"/>
            <a:ext cx="246888" cy="182880"/>
          </a:xfrm>
          <a:prstGeom prst="rect">
            <a:avLst/>
          </a:prstGeom>
          <a:solidFill>
            <a:schemeClr val="bg1">
              <a:alpha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4252165" y="4479679"/>
            <a:ext cx="246888" cy="182880"/>
          </a:xfrm>
          <a:prstGeom prst="rect">
            <a:avLst/>
          </a:prstGeom>
          <a:solidFill>
            <a:schemeClr val="bg1">
              <a:alpha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/>
          </a:p>
        </p:txBody>
      </p:sp>
      <p:graphicFrame>
        <p:nvGraphicFramePr>
          <p:cNvPr id="70" name="Chart 6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2022881"/>
              </p:ext>
            </p:extLst>
          </p:nvPr>
        </p:nvGraphicFramePr>
        <p:xfrm>
          <a:off x="683289" y="3318195"/>
          <a:ext cx="4254746" cy="2022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1263370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3</TotalTime>
  <Words>56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e Sidoli</dc:creator>
  <cp:lastModifiedBy>Simone Sidoli</cp:lastModifiedBy>
  <cp:revision>86</cp:revision>
  <dcterms:created xsi:type="dcterms:W3CDTF">2015-05-05T20:17:23Z</dcterms:created>
  <dcterms:modified xsi:type="dcterms:W3CDTF">2015-09-01T13:40:20Z</dcterms:modified>
</cp:coreProperties>
</file>